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A9129-66AF-4C7B-AE16-5B33CDFC66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339E9-4ECE-4280-A443-E2252748E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577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A9129-66AF-4C7B-AE16-5B33CDFC66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339E9-4ECE-4280-A443-E2252748E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638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A9129-66AF-4C7B-AE16-5B33CDFC66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339E9-4ECE-4280-A443-E2252748E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801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A9129-66AF-4C7B-AE16-5B33CDFC66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339E9-4ECE-4280-A443-E2252748E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629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A9129-66AF-4C7B-AE16-5B33CDFC66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339E9-4ECE-4280-A443-E2252748E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891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A9129-66AF-4C7B-AE16-5B33CDFC66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339E9-4ECE-4280-A443-E2252748E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32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A9129-66AF-4C7B-AE16-5B33CDFC66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339E9-4ECE-4280-A443-E2252748E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103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A9129-66AF-4C7B-AE16-5B33CDFC66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339E9-4ECE-4280-A443-E2252748E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297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A9129-66AF-4C7B-AE16-5B33CDFC66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339E9-4ECE-4280-A443-E2252748E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320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A9129-66AF-4C7B-AE16-5B33CDFC66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339E9-4ECE-4280-A443-E2252748E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857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A9129-66AF-4C7B-AE16-5B33CDFC66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339E9-4ECE-4280-A443-E2252748E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088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A9129-66AF-4C7B-AE16-5B33CDFC66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339E9-4ECE-4280-A443-E2252748E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763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3222" y="605472"/>
            <a:ext cx="9661241" cy="5153644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439333" y="5759116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S29</a:t>
            </a: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. 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Correlation between β-</a:t>
            </a:r>
            <a:r>
              <a:rPr kumimoji="0" lang="vi-VN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µ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M)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nd </a:t>
            </a:r>
            <a:r>
              <a:rPr kumimoji="0" lang="vi-VN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­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µ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M) 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or acridines against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sensitive strain W2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39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8:22Z</dcterms:created>
  <dcterms:modified xsi:type="dcterms:W3CDTF">2020-08-04T16:37:41Z</dcterms:modified>
</cp:coreProperties>
</file>